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8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0874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730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885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534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338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791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92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72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39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302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5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16A9E-817A-4B99-BA13-A160C0FFEDEA}" type="datetimeFigureOut">
              <a:rPr lang="en-US" smtClean="0"/>
              <a:t>6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DEB57-F6CE-4AFE-BFEE-1663219253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645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5975FAD-FFA3-4D19-9C83-7AF327757E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64" y="350698"/>
            <a:ext cx="6154310" cy="360850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FED1380-F28D-4BC0-92A0-89B79A841510}"/>
              </a:ext>
            </a:extLst>
          </p:cNvPr>
          <p:cNvSpPr txBox="1"/>
          <p:nvPr/>
        </p:nvSpPr>
        <p:spPr>
          <a:xfrm>
            <a:off x="0" y="0"/>
            <a:ext cx="81818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Palatino Linotype" panose="02040502050505030304" pitchFamily="18" charset="0"/>
              </a:rPr>
              <a:t>Supplemental Figure 4: </a:t>
            </a:r>
            <a:r>
              <a:rPr lang="en-GB" sz="1200" b="1" i="1" dirty="0">
                <a:latin typeface="Palatino Linotype" panose="02040502050505030304" pitchFamily="18" charset="0"/>
              </a:rPr>
              <a:t>DEPTOR</a:t>
            </a:r>
            <a:r>
              <a:rPr lang="en-GB" sz="1200" b="1" dirty="0">
                <a:latin typeface="Palatino Linotype" panose="02040502050505030304" pitchFamily="18" charset="0"/>
              </a:rPr>
              <a:t> gene amplification correlates with poor prostate cancer patient survival.</a:t>
            </a:r>
            <a:endParaRPr lang="en-US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2580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</TotalTime>
  <Words>1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2</cp:revision>
  <dcterms:created xsi:type="dcterms:W3CDTF">2020-05-13T22:49:02Z</dcterms:created>
  <dcterms:modified xsi:type="dcterms:W3CDTF">2020-06-16T22:36:25Z</dcterms:modified>
</cp:coreProperties>
</file>